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>
      <p:cViewPr varScale="1">
        <p:scale>
          <a:sx n="89" d="100"/>
          <a:sy n="89" d="100"/>
        </p:scale>
        <p:origin x="-720" y="-1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7070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93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4835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2079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1574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1810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9916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0820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8364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7849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211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040A8-5242-496B-9D63-2AF5737B586D}" type="datetimeFigureOut">
              <a:rPr lang="en-AU" smtClean="0"/>
              <a:t>28/11/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9D3C34-DBC5-42F8-B90D-E8825EED51C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2019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9.tiff"/><Relationship Id="rId5" Type="http://schemas.openxmlformats.org/officeDocument/2006/relationships/image" Target="../media/image10.tiff"/><Relationship Id="rId6" Type="http://schemas.openxmlformats.org/officeDocument/2006/relationships/image" Target="../media/image11.tiff"/><Relationship Id="rId7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4" Type="http://schemas.openxmlformats.org/officeDocument/2006/relationships/image" Target="../media/image15.tiff"/><Relationship Id="rId5" Type="http://schemas.openxmlformats.org/officeDocument/2006/relationships/image" Target="../media/image16.tiff"/><Relationship Id="rId6" Type="http://schemas.openxmlformats.org/officeDocument/2006/relationships/image" Target="../media/image17.tiff"/><Relationship Id="rId7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4" Type="http://schemas.openxmlformats.org/officeDocument/2006/relationships/image" Target="../media/image21.jpeg"/><Relationship Id="rId5" Type="http://schemas.openxmlformats.org/officeDocument/2006/relationships/image" Target="../media/image22.jpeg"/><Relationship Id="rId6" Type="http://schemas.openxmlformats.org/officeDocument/2006/relationships/image" Target="../media/image23.jpeg"/><Relationship Id="rId7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4" Type="http://schemas.openxmlformats.org/officeDocument/2006/relationships/image" Target="../media/image27.jpeg"/><Relationship Id="rId5" Type="http://schemas.openxmlformats.org/officeDocument/2006/relationships/image" Target="../media/image28.jpeg"/><Relationship Id="rId6" Type="http://schemas.openxmlformats.org/officeDocument/2006/relationships/image" Target="../media/image29.jpeg"/><Relationship Id="rId7" Type="http://schemas.openxmlformats.org/officeDocument/2006/relationships/image" Target="../media/image30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4" Type="http://schemas.openxmlformats.org/officeDocument/2006/relationships/image" Target="../media/image33.tiff"/><Relationship Id="rId5" Type="http://schemas.openxmlformats.org/officeDocument/2006/relationships/image" Target="../media/image34.tiff"/><Relationship Id="rId6" Type="http://schemas.openxmlformats.org/officeDocument/2006/relationships/image" Target="../media/image35.tiff"/><Relationship Id="rId7" Type="http://schemas.openxmlformats.org/officeDocument/2006/relationships/image" Target="../media/image36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4" Type="http://schemas.openxmlformats.org/officeDocument/2006/relationships/image" Target="../media/image39.jpeg"/><Relationship Id="rId5" Type="http://schemas.openxmlformats.org/officeDocument/2006/relationships/image" Target="../media/image40.jpeg"/><Relationship Id="rId6" Type="http://schemas.openxmlformats.org/officeDocument/2006/relationships/image" Target="../media/image41.jpeg"/><Relationship Id="rId7" Type="http://schemas.openxmlformats.org/officeDocument/2006/relationships/image" Target="../media/image42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AU" dirty="0" smtClean="0"/>
              <a:t>APOCYNIN INHIBTION OF METS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934221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1</a:t>
            </a:r>
            <a:endParaRPr lang="en-AU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935" y="1342594"/>
            <a:ext cx="2064160" cy="16513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936" y="2993922"/>
            <a:ext cx="2064160" cy="167148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936" y="4665406"/>
            <a:ext cx="2064160" cy="178455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6537" y="1368314"/>
            <a:ext cx="2104718" cy="165132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6537" y="3006782"/>
            <a:ext cx="2104719" cy="16714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6537" y="4678266"/>
            <a:ext cx="2104719" cy="178455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696161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2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935" y="1368314"/>
            <a:ext cx="2064161" cy="162560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934" y="2993922"/>
            <a:ext cx="2064162" cy="160265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3933" y="4596580"/>
            <a:ext cx="2064163" cy="173047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3438" y="1368314"/>
            <a:ext cx="2163096" cy="1625608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3439" y="2993922"/>
            <a:ext cx="2163096" cy="160265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3438" y="4596580"/>
            <a:ext cx="2163096" cy="1682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09630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3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4941" y="1368315"/>
            <a:ext cx="2215331" cy="162560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4941" y="2993922"/>
            <a:ext cx="2215331" cy="160265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4940" y="4596580"/>
            <a:ext cx="2215332" cy="175358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1257" y="1368315"/>
            <a:ext cx="2157569" cy="162560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6176" y="2993922"/>
            <a:ext cx="2152650" cy="160265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8632" y="4596579"/>
            <a:ext cx="2150194" cy="1753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454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4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4550" y="1368315"/>
            <a:ext cx="2077065" cy="162560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4550" y="2993922"/>
            <a:ext cx="2077065" cy="160265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4549" y="4596579"/>
            <a:ext cx="2077065" cy="175358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7963" y="1368315"/>
            <a:ext cx="2208571" cy="162560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7963" y="2993922"/>
            <a:ext cx="2208571" cy="1602657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7963" y="4596579"/>
            <a:ext cx="2208571" cy="1753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11588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5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4594" y="1368314"/>
            <a:ext cx="2067019" cy="162560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4594" y="2993922"/>
            <a:ext cx="2067019" cy="160265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4594" y="4596579"/>
            <a:ext cx="2067019" cy="175358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0841" y="1368314"/>
            <a:ext cx="2032009" cy="162560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0841" y="2993921"/>
            <a:ext cx="2032009" cy="160265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0841" y="4596578"/>
            <a:ext cx="2032009" cy="1753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43394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6</a:t>
            </a:r>
            <a:endParaRPr lang="en-AU" sz="3100" dirty="0"/>
          </a:p>
        </p:txBody>
      </p:sp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7204" y="1368314"/>
            <a:ext cx="2178151" cy="162560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7204" y="2993921"/>
            <a:ext cx="2178151" cy="1602657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7203" y="4562990"/>
            <a:ext cx="2178151" cy="178717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4555" y="1359296"/>
            <a:ext cx="2191979" cy="163462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4555" y="2993921"/>
            <a:ext cx="2191980" cy="156906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4555" y="4562990"/>
            <a:ext cx="2191980" cy="1787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11781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0952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PATIENT </a:t>
            </a:r>
            <a:r>
              <a:rPr lang="en-AU" dirty="0" smtClean="0"/>
              <a:t>7</a:t>
            </a:r>
            <a:endParaRPr lang="en-AU" sz="3100" dirty="0"/>
          </a:p>
        </p:txBody>
      </p:sp>
      <p:sp>
        <p:nvSpPr>
          <p:cNvPr id="7" name="TextBox 6"/>
          <p:cNvSpPr txBox="1"/>
          <p:nvPr/>
        </p:nvSpPr>
        <p:spPr>
          <a:xfrm>
            <a:off x="2791749" y="919508"/>
            <a:ext cx="943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</a:t>
            </a:r>
            <a:endParaRPr lang="en-AU" dirty="0"/>
          </a:p>
        </p:txBody>
      </p:sp>
      <p:sp>
        <p:nvSpPr>
          <p:cNvPr id="12" name="TextBox 11"/>
          <p:cNvSpPr txBox="1"/>
          <p:nvPr/>
        </p:nvSpPr>
        <p:spPr>
          <a:xfrm>
            <a:off x="5531257" y="919508"/>
            <a:ext cx="203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NTHI + APOCYNIN</a:t>
            </a:r>
            <a:endParaRPr lang="en-AU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3879" y="1359296"/>
            <a:ext cx="2044495" cy="16346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3879" y="2993921"/>
            <a:ext cx="2044495" cy="156906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3879" y="4562990"/>
            <a:ext cx="2044495" cy="178717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859" y="1358325"/>
            <a:ext cx="2044495" cy="163559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859" y="2993921"/>
            <a:ext cx="2044495" cy="156906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859" y="4562990"/>
            <a:ext cx="2044495" cy="1787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6492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46</Words>
  <Application>Microsoft Macintosh PowerPoint</Application>
  <PresentationFormat>Custom</PresentationFormat>
  <Paragraphs>22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APOCYNIN INHIBTION OF METS</vt:lpstr>
      <vt:lpstr>PATIENT 1</vt:lpstr>
      <vt:lpstr>PATIENT 2</vt:lpstr>
      <vt:lpstr>PATIENT 3</vt:lpstr>
      <vt:lpstr>PATIENT 4</vt:lpstr>
      <vt:lpstr>PATIENT 5</vt:lpstr>
      <vt:lpstr>PATIENT 6</vt:lpstr>
      <vt:lpstr>PATIENT 7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OCYNIN MACROPHAGE PICS</dc:title>
  <dc:creator>Roleen</dc:creator>
  <cp:lastModifiedBy>Paul King</cp:lastModifiedBy>
  <cp:revision>12</cp:revision>
  <dcterms:created xsi:type="dcterms:W3CDTF">2014-11-21T01:46:35Z</dcterms:created>
  <dcterms:modified xsi:type="dcterms:W3CDTF">2014-11-28T09:27:28Z</dcterms:modified>
</cp:coreProperties>
</file>